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0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D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8" d="100"/>
          <a:sy n="108" d="100"/>
        </p:scale>
        <p:origin x="1704" y="10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05/02/2018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60027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5/02/2018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5/02/2018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5/02/2018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5/02/2018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5/02/2018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5/02/2018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5/02/2018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5/02/2018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5/02/2018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5/02/2018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5/02/2018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05/02/2018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232552" y="5626695"/>
            <a:ext cx="799288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en-GB" dirty="0"/>
              <a:t>Author Choudhary and Amiel (2018) Diabetologia DOI 10.1007/s00125-018-4566-6</a:t>
            </a:r>
          </a:p>
          <a:p>
            <a:r>
              <a:rPr lang="en-GB" sz="1200" dirty="0"/>
              <a:t>© The Authors 2018. Distributed under the terms of the CC BY 4.0 Attribution License (http://creativecommons.org/licenses/by/4.0/)</a:t>
            </a:r>
          </a:p>
        </p:txBody>
      </p:sp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323528" y="260648"/>
            <a:ext cx="871296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Download of data from a continuous glucose sensor (above) and capillary glucose monitoring (below) for a woman with long-duration type 1 diabetes </a:t>
            </a:r>
            <a:endParaRPr lang="en-GB" sz="2000" b="1" dirty="0"/>
          </a:p>
        </p:txBody>
      </p:sp>
      <p:sp>
        <p:nvSpPr>
          <p:cNvPr id="2" name="Rectangle 1"/>
          <p:cNvSpPr/>
          <p:nvPr/>
        </p:nvSpPr>
        <p:spPr>
          <a:xfrm>
            <a:off x="2339752" y="1556792"/>
            <a:ext cx="5112568" cy="3024336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FIGURE HERE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7B26CC90-B2C4-45DA-B5BC-262CBA8B8B6C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03648" y="930797"/>
            <a:ext cx="6336704" cy="490348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5991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71</TotalTime>
  <Words>70</Words>
  <Application>Microsoft Office PowerPoint</Application>
  <PresentationFormat>On-screen Show (4:3)</PresentationFormat>
  <Paragraphs>6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Charlotte Taylor</cp:lastModifiedBy>
  <cp:revision>31</cp:revision>
  <dcterms:created xsi:type="dcterms:W3CDTF">2016-06-15T12:53:43Z</dcterms:created>
  <dcterms:modified xsi:type="dcterms:W3CDTF">2018-02-05T09:50:35Z</dcterms:modified>
</cp:coreProperties>
</file>